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2077" autoAdjust="0"/>
  </p:normalViewPr>
  <p:slideViewPr>
    <p:cSldViewPr snapToGrid="0">
      <p:cViewPr>
        <p:scale>
          <a:sx n="50" d="100"/>
          <a:sy n="50" d="100"/>
        </p:scale>
        <p:origin x="1906" y="9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F620AE2-CFD4-4DC7-9FE8-B7F82594697F}" type="datetimeFigureOut">
              <a:rPr lang="es-ES" smtClean="0"/>
              <a:t>30/04/2026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C9FD5FB-4BF5-47C5-9FC6-A322B897483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35598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 smtClean="0"/>
              <a:t>Supplementary</a:t>
            </a:r>
            <a:r>
              <a:rPr lang="en-US" b="1" baseline="0" dirty="0" smtClean="0"/>
              <a:t> Figure 1</a:t>
            </a:r>
            <a:r>
              <a:rPr lang="en-US" b="1" dirty="0" smtClean="0"/>
              <a:t>. Risk-of-bias assessment of external material (database studies and validation cohorts). </a:t>
            </a:r>
            <a:r>
              <a:rPr lang="en-US" dirty="0" smtClean="0"/>
              <a:t>Risk of bias was evaluated across four predefined domains (D1–D4) and summarized as an overall judgement for each study. The upper panel displays study-level assessments, where each symbol represents the judgement per domain (green: low risk; red: high risk; grey: unclear). The lower panel shows the distribution of risk-of-bias judgements across studies for each domain and overall.</a:t>
            </a:r>
            <a:endParaRPr lang="es-MX" dirty="0" smtClean="0"/>
          </a:p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C9FD5FB-4BF5-47C5-9FC6-A322B897483A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922402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A7FC8-7021-4970-8F9F-36D505635D7C}" type="datetimeFigureOut">
              <a:rPr lang="es-ES" smtClean="0"/>
              <a:t>30/04/202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CC3AC-2F0D-4DFA-A58D-D5E4C699B06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887040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A7FC8-7021-4970-8F9F-36D505635D7C}" type="datetimeFigureOut">
              <a:rPr lang="es-ES" smtClean="0"/>
              <a:t>30/04/202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CC3AC-2F0D-4DFA-A58D-D5E4C699B06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189159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A7FC8-7021-4970-8F9F-36D505635D7C}" type="datetimeFigureOut">
              <a:rPr lang="es-ES" smtClean="0"/>
              <a:t>30/04/202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CC3AC-2F0D-4DFA-A58D-D5E4C699B06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434235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A7FC8-7021-4970-8F9F-36D505635D7C}" type="datetimeFigureOut">
              <a:rPr lang="es-ES" smtClean="0"/>
              <a:t>30/04/202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CC3AC-2F0D-4DFA-A58D-D5E4C699B06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502349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A7FC8-7021-4970-8F9F-36D505635D7C}" type="datetimeFigureOut">
              <a:rPr lang="es-ES" smtClean="0"/>
              <a:t>30/04/202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CC3AC-2F0D-4DFA-A58D-D5E4C699B06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999408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A7FC8-7021-4970-8F9F-36D505635D7C}" type="datetimeFigureOut">
              <a:rPr lang="es-ES" smtClean="0"/>
              <a:t>30/04/2026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CC3AC-2F0D-4DFA-A58D-D5E4C699B06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123024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A7FC8-7021-4970-8F9F-36D505635D7C}" type="datetimeFigureOut">
              <a:rPr lang="es-ES" smtClean="0"/>
              <a:t>30/04/2026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CC3AC-2F0D-4DFA-A58D-D5E4C699B06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19618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A7FC8-7021-4970-8F9F-36D505635D7C}" type="datetimeFigureOut">
              <a:rPr lang="es-ES" smtClean="0"/>
              <a:t>30/04/2026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CC3AC-2F0D-4DFA-A58D-D5E4C699B06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084140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A7FC8-7021-4970-8F9F-36D505635D7C}" type="datetimeFigureOut">
              <a:rPr lang="es-ES" smtClean="0"/>
              <a:t>30/04/2026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CC3AC-2F0D-4DFA-A58D-D5E4C699B06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062176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A7FC8-7021-4970-8F9F-36D505635D7C}" type="datetimeFigureOut">
              <a:rPr lang="es-ES" smtClean="0"/>
              <a:t>30/04/2026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CC3AC-2F0D-4DFA-A58D-D5E4C699B06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161407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A7FC8-7021-4970-8F9F-36D505635D7C}" type="datetimeFigureOut">
              <a:rPr lang="es-ES" smtClean="0"/>
              <a:t>30/04/2026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CC3AC-2F0D-4DFA-A58D-D5E4C699B06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26714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BA7FC8-7021-4970-8F9F-36D505635D7C}" type="datetimeFigureOut">
              <a:rPr lang="es-ES" smtClean="0"/>
              <a:t>30/04/202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8CC3AC-2F0D-4DFA-A58D-D5E4C699B06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033959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ángulo 1"/>
          <p:cNvSpPr/>
          <p:nvPr/>
        </p:nvSpPr>
        <p:spPr>
          <a:xfrm>
            <a:off x="7274169" y="5206038"/>
            <a:ext cx="4451420" cy="14465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defRPr/>
            </a:pPr>
            <a:r>
              <a:rPr lang="en-US" sz="1100" b="1" dirty="0"/>
              <a:t>Supplementary Figure 1. Risk-of-bias assessment of external material (database studies and validation cohorts). </a:t>
            </a:r>
            <a:r>
              <a:rPr lang="en-US" sz="1100" dirty="0"/>
              <a:t>Risk of bias was evaluated across four predefined domains (D1–D4) and summarized as an overall judgement for each study. The upper panel displays study-level assessments, where each symbol represents the judgement per domain (green: low risk; red: high risk; grey: unclear). The lower panel shows the distribution of risk-of-bias judgements across studies for each domain and overall.</a:t>
            </a:r>
            <a:endParaRPr lang="es-MX" sz="1100" dirty="0"/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3360" y="447692"/>
            <a:ext cx="6204896" cy="62048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3601175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1</Words>
  <Application>Microsoft Office PowerPoint</Application>
  <PresentationFormat>Panorámica</PresentationFormat>
  <Paragraphs>3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DOCU</dc:creator>
  <cp:lastModifiedBy>DOCU</cp:lastModifiedBy>
  <cp:revision>3</cp:revision>
  <dcterms:created xsi:type="dcterms:W3CDTF">2026-03-26T18:16:09Z</dcterms:created>
  <dcterms:modified xsi:type="dcterms:W3CDTF">2026-04-30T12:22:35Z</dcterms:modified>
</cp:coreProperties>
</file>